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0"/>
    <p:restoredTop sz="94654"/>
  </p:normalViewPr>
  <p:slideViewPr>
    <p:cSldViewPr snapToGrid="0">
      <p:cViewPr varScale="1">
        <p:scale>
          <a:sx n="102" d="100"/>
          <a:sy n="102" d="100"/>
        </p:scale>
        <p:origin x="21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CDFD1-5304-4484-25B7-B9B9F8709A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D48735-D953-C1EF-16B2-494C140B22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118CD-B1BE-54EF-5805-9CA56EA4F5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906D69-3EAB-24D0-27E6-818DE25E1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67A6C3-6FB4-E9C0-D959-34068E17D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180906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15D60-ADF1-E657-98F9-A630C0D18A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D9BDAE-BAA6-105C-E6DE-946E86D8C3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E4253A-86B7-64C0-5D42-BC85A3656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1FAFF7-F00C-EDA7-23EF-4F85D1DC2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02C3D3-39AE-3ECB-E474-EF9C6FF17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2853760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0DEA7F-15FA-A884-336E-E6EC3FFD88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6B3435-63E1-C653-38C9-ED41BA2EFB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02532B-0758-4099-E5ED-20C7BD8F4D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511C75-41DD-5B18-554B-4A31EDB1C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0ACD42-5870-9298-7E58-44BD75229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2641724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DBAADC-B69D-0B8F-3669-70998F1930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C9CF4B-722A-B3C0-46AE-821ACE58BD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6C6E61-C28E-440D-094D-D24BDC852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30DFCB-152C-DDB3-9385-A9CB08EEC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6ACE88-0230-F653-E36A-665E8A86E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635271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2F4352-8B59-D61C-58CA-756B8A619A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B30A59-97C3-EB34-5A8A-032281C269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C04D1F-C8EA-9E4D-AD42-E5BDA9263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BA3A61-D34B-0B84-4D4A-93DFADF69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B69BB2-C9EC-4A5C-3B3E-4507FE315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440126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CD67AA-EA3F-4A6F-CF22-A14F5B625D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D266D5-524B-EB76-4427-E129B616AA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1EEDE1-5CEE-A0FF-9402-B1504317B0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306CD9-7D2D-9CAD-D297-5D94B368E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8E5185-A319-8D31-51E0-D4E76EAB5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07BDDB-1080-DA8F-B1AB-35B8E22013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796327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4688FC-1FA0-4C80-DC4C-DDA0D4F99B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C76E8A-DB87-000B-41E4-BB97473FDD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EACF6A-8D35-6C28-3F34-FF491ABA23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55795D-EECB-3F70-0CCC-0325A98915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B8CD4C-9974-65D3-F7F6-A1C9FB12ED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A0517C-D483-2926-71BA-E39246A86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38A619-FD3C-DB2E-E99A-D7997F2CD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6DDBC1-59F5-20D8-A4B2-5D527C982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693923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52BCB2-FF59-DF33-044C-757AEB7DC0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FCF7A6-C970-1531-4684-914BED972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70AFFD-329D-FC34-DCBB-464232C27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2B874AD-4A8E-D582-7DBC-760010F5E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78911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2CC016-CD26-A021-AC75-413B920DF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77FD65-7799-8256-447D-64037C29A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FB4BC7-447F-9883-C282-8C0651C61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2434644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4F5F4-7EDE-4200-848B-9A151208AD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57327-6C00-9AEE-EB04-CF7AD86B97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46A3E9-2657-7F77-5AA3-C0E8521099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5A6C84-6781-EC14-1AA5-290C481BE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52092D-E51C-7B97-D167-7BD561FB3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011594-752E-0448-0FB8-730B1EB5F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244658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2E26A5-A6D0-81AA-AB16-36E2B086F3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582DDE3-4137-B5D7-FAD3-D47993223B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390AD3-288C-EE03-91E9-D5684BDFFD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8E87FE-8BD4-374A-C55D-3C7CBC404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2ECB0B-F626-85DE-26A6-9BDBE06BA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FCF57F-4956-8DF7-EFAA-460FF5074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3963387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1E7053-C46D-D859-6557-A9FA0CBB70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4AC9DD-5FFC-19F4-0235-1DD0985CA4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64A3D7-9173-0BAF-BB4C-93BE31F9A1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A3C13B3-B6B0-5047-894D-CD144BC329B7}" type="datetimeFigureOut">
              <a:rPr lang="en-GR" smtClean="0"/>
              <a:t>31/5/24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87C149-FAAA-C46B-EDA4-9BB680CDCA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FBB63E-1CCD-59ED-5426-C5D9C6F0DD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0EBE58-CD2F-F94A-97FA-9376FDE5EBAE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925165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6ACD22F-3651-3775-0376-96D35B2D8FB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1518557" y="892195"/>
            <a:ext cx="8752110" cy="618443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D5DF134-6C65-A45D-35B1-6B2FED90E2BB}"/>
              </a:ext>
            </a:extLst>
          </p:cNvPr>
          <p:cNvSpPr txBox="1"/>
          <p:nvPr/>
        </p:nvSpPr>
        <p:spPr>
          <a:xfrm>
            <a:off x="2085974" y="424543"/>
            <a:ext cx="72208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 Table 2. Variation of each morphological parameter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 fruits, leaves and endocarps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the two years of study of each cultivar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Each morphological parameter is colored from red (high variability) to green (low variability). The trait variation was calculated as the average of each cultivar’s trait variation. </a:t>
            </a:r>
            <a:endParaRPr lang="en-G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1631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6ACD22F-3651-3775-0376-96D35B2D8FB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1540329" y="107944"/>
            <a:ext cx="9399812" cy="66421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33203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6ACD22F-3651-3775-0376-96D35B2D8FB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751114" y="124273"/>
            <a:ext cx="10940141" cy="7730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9765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6</Words>
  <Application>Microsoft Macintosh PowerPoint</Application>
  <PresentationFormat>Widescreen</PresentationFormat>
  <Paragraphs>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2</cp:revision>
  <dcterms:created xsi:type="dcterms:W3CDTF">2024-05-31T08:40:26Z</dcterms:created>
  <dcterms:modified xsi:type="dcterms:W3CDTF">2024-05-31T08:51:58Z</dcterms:modified>
</cp:coreProperties>
</file>